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735763" cy="9866313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9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2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276" y="84"/>
      </p:cViewPr>
      <p:guideLst>
        <p:guide orient="horz" pos="3097"/>
        <p:guide pos="9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6F0E7-FD15-4EE7-BE7E-B91504887E1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5C57E6-2FC1-4B7F-A9C1-B7C3BF2B536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06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7C0C4-86BD-44AA-BA48-532F3CE388A5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560C63-0E5F-4F79-9E19-8EDA44005DC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421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7B5FDA-F372-48DD-8C3C-370C9015FCF9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489A9E-3EB9-4DB6-87D4-E740B71B8816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99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C0D9D5-3A67-4F9A-B958-5F084B9A1776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4AF34-1DC5-4FAE-A874-2AFC6626EFC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2877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361E0F-CBB6-4295-BEF5-8D6CEFAAD7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64C392-1ABB-401C-9E09-E0F4E77A4BA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22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9371B6-4E15-474F-BEF5-8DF1A0CC3F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7DBF49-C2EE-4243-9DDA-ECACE02EE4F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529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D3B6B8-3310-42C8-9503-82E0DD06A17C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2C61DC-EF6C-42CF-A95F-5EA824D88A5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682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E2FFB8-10C3-4DDC-BFB1-F5DA96EF200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B3A4582-A24B-43AE-8848-B28F27B1CA3D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86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840C8-D884-4585-AE4B-8A84B519972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17750D-E422-4FA2-8A8E-9F144631D8F0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82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DEA246-8415-4F73-B506-4EF236446FB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9242D4-7F37-4765-8228-AFFD464C80C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43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1402F-2B5F-41A6-A9E1-308A4E1683E7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AACC69-91FE-4395-AD7C-3667926C054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9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altLang="ko-KR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altLang="ko-KR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E52F96B-E043-4EF3-850C-A79CC90021C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900">
                <a:solidFill>
                  <a:srgbClr val="898989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</a:lstStyle>
          <a:p>
            <a:fld id="{C31CD9A6-5F9B-407A-AD78-81B512AE21E6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2pPr>
      <a:lvl3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3pPr>
      <a:lvl4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4pPr>
      <a:lvl5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5pPr>
      <a:lvl6pPr marL="4572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6pPr>
      <a:lvl7pPr marL="9144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7pPr>
      <a:lvl8pPr marL="13716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8pPr>
      <a:lvl9pPr marL="18288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9pPr>
    </p:titleStyle>
    <p:bodyStyle>
      <a:lvl1pPr marL="171450" indent="-171450" algn="l" defTabSz="685800" rtl="0" eaLnBrk="0" fontAlgn="base" latinLnBrk="1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592946" y="925280"/>
            <a:ext cx="58582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100" b="1" kern="100" dirty="0" smtClean="0">
                <a:latin typeface="Times New Roman" panose="02020603050405020304" pitchFamily="18" charset="0"/>
                <a:ea typeface="바탕체" panose="02030609000101010101" pitchFamily="17" charset="-127"/>
              </a:rPr>
              <a:t>S1 Table. Primers for detection of target genes.</a:t>
            </a:r>
            <a:endParaRPr lang="ko-KR" altLang="ko-KR" sz="1100" kern="100" dirty="0">
              <a:effectLst/>
              <a:latin typeface="Times New Roman" panose="02020603050405020304" pitchFamily="18" charset="0"/>
              <a:ea typeface="바탕체" panose="02030609000101010101" pitchFamily="17" charset="-127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0407240"/>
              </p:ext>
            </p:extLst>
          </p:nvPr>
        </p:nvGraphicFramePr>
        <p:xfrm>
          <a:off x="679704" y="1453896"/>
          <a:ext cx="5647944" cy="12242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210056"/>
                <a:gridCol w="2218944"/>
                <a:gridCol w="2218944"/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s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r>
                        <a:rPr lang="en-US" altLang="ko-KR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rimer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onectin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AAC TTG CAT CTG GAG GCA AAC CCT -3’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TCT GTC CCA GGC AGG AGA TTT GTT -3’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-</a:t>
                      </a:r>
                      <a:r>
                        <a:rPr lang="el-GR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CAG AAA TAC AGC AAC AAT TCC TGG -3’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G TCC AGG CTC CAA ATA TAG G -3’</a:t>
                      </a: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06405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6</TotalTime>
  <Words>71</Words>
  <Application>Microsoft Office PowerPoint</Application>
  <PresentationFormat>A4 용지(210x297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굴림</vt:lpstr>
      <vt:lpstr>맑은 고딕</vt:lpstr>
      <vt:lpstr>바탕체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대령</dc:creator>
  <cp:lastModifiedBy>Windows User</cp:lastModifiedBy>
  <cp:revision>225</cp:revision>
  <cp:lastPrinted>2014-07-29T08:24:50Z</cp:lastPrinted>
  <dcterms:created xsi:type="dcterms:W3CDTF">2014-05-21T07:45:37Z</dcterms:created>
  <dcterms:modified xsi:type="dcterms:W3CDTF">2016-01-30T02:34:05Z</dcterms:modified>
</cp:coreProperties>
</file>